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6" d="100"/>
          <a:sy n="86" d="100"/>
        </p:scale>
        <p:origin x="708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6018938-0AFA-3025-F1C3-2B941FA9B5F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C606FBF8-9414-1D82-CF55-A2CB09FA1D5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0D396EE-7689-73CD-AA44-59BC10EA3F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A88B57-8144-462F-BF82-1E3BE6160D21}" type="datetimeFigureOut">
              <a:rPr lang="zh-CN" altLang="en-US" smtClean="0"/>
              <a:t>2024/9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28CD11D-7446-6977-CEC7-EF62848AF5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D7AB8D7-47F7-54B2-9473-4BDFC60684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B09F05-D3EA-4D8A-860A-FB3899E13A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970965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C442C7D-5453-EFFB-2CF0-AB2CFBFAF19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CD7BBC70-712E-90F2-EE14-F40FF852D46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A83CD72-E9C7-512D-016D-BDF684BFF1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A88B57-8144-462F-BF82-1E3BE6160D21}" type="datetimeFigureOut">
              <a:rPr lang="zh-CN" altLang="en-US" smtClean="0"/>
              <a:t>2024/9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7B4256A-120D-A2CD-BAA8-108443DC6B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8626F88-E166-69B7-4562-BDA81EF094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B09F05-D3EA-4D8A-860A-FB3899E13A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081784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E028DEB9-DDA1-7FAF-1205-99A1CEDF92C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0B781377-DF0C-2ACF-68D1-C4D3FA39738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76A53E0-E070-85A5-E045-9867A99632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A88B57-8144-462F-BF82-1E3BE6160D21}" type="datetimeFigureOut">
              <a:rPr lang="zh-CN" altLang="en-US" smtClean="0"/>
              <a:t>2024/9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7B32913-0840-5051-8EA5-6750C6F219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D993F8F-2A40-1678-72BF-9D7F74560A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B09F05-D3EA-4D8A-860A-FB3899E13A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019515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CA0587D-EFFD-7534-3D18-D3289DB0BDE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C616763-DAA4-BD6A-A022-1C380B51737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894CF94-9A9C-746C-BD1E-AB243E1847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A88B57-8144-462F-BF82-1E3BE6160D21}" type="datetimeFigureOut">
              <a:rPr lang="zh-CN" altLang="en-US" smtClean="0"/>
              <a:t>2024/9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CAC9FDB-83C6-C8E6-51A7-93DB8C0EA8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58E8CE5-2123-E486-CA7E-87D3F56DC8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B09F05-D3EA-4D8A-860A-FB3899E13A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964498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329690C-4212-E43D-E1BA-32D77CB28E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2FCF75F-56F7-132E-6B7C-EE467A9A0C8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4FC242C-AA4E-E8EC-4B2A-3606300409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A88B57-8144-462F-BF82-1E3BE6160D21}" type="datetimeFigureOut">
              <a:rPr lang="zh-CN" altLang="en-US" smtClean="0"/>
              <a:t>2024/9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85EF326-CEB1-61EF-A048-BDDD5D1745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5497269-23A4-EFFB-B296-87E840470C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B09F05-D3EA-4D8A-860A-FB3899E13A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559182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614F2B2-3474-2E09-9FD6-A2CA871E821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E372CD7-CD17-4DBA-A2AA-08E52B34A1C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7D0BF518-8CF6-29C6-4B12-8DAD8C71BE3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D80193F-6B8D-8215-58E1-9D115F37C0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A88B57-8144-462F-BF82-1E3BE6160D21}" type="datetimeFigureOut">
              <a:rPr lang="zh-CN" altLang="en-US" smtClean="0"/>
              <a:t>2024/9/1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32B3650-9387-BFFD-B91E-7D28D98859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D070BD3-AF98-95E3-8EF1-D629F06E2A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B09F05-D3EA-4D8A-860A-FB3899E13A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763594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C4451D7-E3AE-5AF7-3A97-C953C9B264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80E2966-BBE1-D7EA-0830-7F13B11D053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0F22069A-ACCD-0F41-2E2C-FFF46004620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7962804C-CF1C-F9EB-33F4-665A666CC54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47C1632C-580B-1A42-B5A5-EE45FC16BFB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DFC20B0B-AAFE-4D85-6878-C09271CECD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A88B57-8144-462F-BF82-1E3BE6160D21}" type="datetimeFigureOut">
              <a:rPr lang="zh-CN" altLang="en-US" smtClean="0"/>
              <a:t>2024/9/16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C83EA6C8-116B-3889-EA4A-E75DAC79AF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208B1674-308C-424B-0784-F91490722B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B09F05-D3EA-4D8A-860A-FB3899E13A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256980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D4F31D3-4387-84C2-ECD8-92E780983DA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90C75E84-DEB0-70DD-B5CF-1F04CDEE57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A88B57-8144-462F-BF82-1E3BE6160D21}" type="datetimeFigureOut">
              <a:rPr lang="zh-CN" altLang="en-US" smtClean="0"/>
              <a:t>2024/9/16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59E70982-7A9C-CBD4-2C66-51BC4ADB2F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174B7468-AA27-3D7D-1A98-FEDA9B85EB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B09F05-D3EA-4D8A-860A-FB3899E13A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615386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D60D355B-BF50-888D-60D3-3EA50ECA23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A88B57-8144-462F-BF82-1E3BE6160D21}" type="datetimeFigureOut">
              <a:rPr lang="zh-CN" altLang="en-US" smtClean="0"/>
              <a:t>2024/9/16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2345A036-749C-031C-D23D-CF4B8635C6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FF17ABBD-5F75-7230-8D27-5663486304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B09F05-D3EA-4D8A-860A-FB3899E13A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017245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70E9678-ED49-57B9-A746-CED1C5B6A3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1DC68DD-3C35-EB0C-CA29-52E65B955AD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103E22AE-A6D4-446A-7058-DC2FB8D3CDC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F39FC05-7AEF-E5DA-7A79-31687594A5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A88B57-8144-462F-BF82-1E3BE6160D21}" type="datetimeFigureOut">
              <a:rPr lang="zh-CN" altLang="en-US" smtClean="0"/>
              <a:t>2024/9/1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72A588F-8BE9-D95F-7B96-8D763C811F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0685C5C-C2BF-B7B7-5497-53152C9FD2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B09F05-D3EA-4D8A-860A-FB3899E13A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623470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F6BF9F9-DF95-77BE-0494-7E0519FA2F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8B8DEF36-0139-0297-8E62-9AAF14BD091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EBA4C5E8-647D-DC50-95FF-FA09AE0A27C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56A0FD1-12C6-C6AF-3AA8-2BEBE2D781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A88B57-8144-462F-BF82-1E3BE6160D21}" type="datetimeFigureOut">
              <a:rPr lang="zh-CN" altLang="en-US" smtClean="0"/>
              <a:t>2024/9/1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512522D-32CC-3FB9-EE59-9619FE52DA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C337570-3DF2-9C9F-FBDF-D6726504D5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B09F05-D3EA-4D8A-860A-FB3899E13A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728185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ED5E8F0D-6B4B-ACC1-9AE2-385B5E22EB6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8B63268-A2FF-0972-3FBF-DCBDFB6D148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8CC456E-12CE-BD8A-DAB4-BAAE799D0D4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A88B57-8144-462F-BF82-1E3BE6160D21}" type="datetimeFigureOut">
              <a:rPr lang="zh-CN" altLang="en-US" smtClean="0"/>
              <a:t>2024/9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B57F28D-52C8-B562-F9C0-E6549DECAEE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5E1FC80-48F0-D8BF-BFB7-8075571BC29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B09F05-D3EA-4D8A-860A-FB3899E13A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701542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2E500344-D025-4BB2-823F-0C0778E1EDE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64512" y="1467163"/>
            <a:ext cx="9462976" cy="3923673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364512" y="5832088"/>
            <a:ext cx="971516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S1. The U-shaped curve adjusted for confounding variables depicting the relationship between </a:t>
            </a:r>
            <a:r>
              <a:rPr lang="en-US" dirty="0" smtClean="0"/>
              <a:t/>
            </a:r>
            <a:br>
              <a:rPr lang="en-US" dirty="0" smtClean="0"/>
            </a:br>
            <a:r>
              <a:rPr lang="en-US" dirty="0" smtClean="0"/>
              <a:t>post-ablation </a:t>
            </a:r>
            <a:r>
              <a:rPr lang="en-US" dirty="0"/>
              <a:t>peak temperature and Very Early Recurrence (VER) and Early Recurrence (ER</a:t>
            </a:r>
            <a:r>
              <a:rPr lang="en-US" dirty="0" smtClean="0"/>
              <a:t>).</a:t>
            </a:r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13218234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31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等线</vt:lpstr>
      <vt:lpstr>等线 Light</vt:lpstr>
      <vt:lpstr>Office 主题​​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倩 蔡</dc:creator>
  <cp:lastModifiedBy>Karthikeyan S</cp:lastModifiedBy>
  <cp:revision>3</cp:revision>
  <dcterms:created xsi:type="dcterms:W3CDTF">2024-03-16T11:25:03Z</dcterms:created>
  <dcterms:modified xsi:type="dcterms:W3CDTF">2024-09-16T12:13:08Z</dcterms:modified>
</cp:coreProperties>
</file>